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60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4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2005" y="55880"/>
            <a:ext cx="6999605" cy="5386705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2072005" y="5676900"/>
            <a:ext cx="6985000" cy="64516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altLang="zh-CN" sz="1200" b="0">
                <a:solidFill>
                  <a:srgbClr val="131413"/>
                </a:solidFill>
                <a:latin typeface="Times New Roman" panose="02020603050405020304" charset="0"/>
                <a:cs typeface="Times New Roman" panose="02020603050405020304" charset="0"/>
              </a:rPr>
              <a:t>Fig.S1. Representative one-dimensional </a:t>
            </a:r>
            <a:r>
              <a:rPr lang="en-US" altLang="zh-CN" sz="1200" b="0" baseline="30000">
                <a:solidFill>
                  <a:srgbClr val="131413"/>
                </a:solidFill>
                <a:latin typeface="Times New Roman" panose="02020603050405020304" charset="0"/>
                <a:cs typeface="Times New Roman" panose="02020603050405020304" charset="0"/>
              </a:rPr>
              <a:t>1</a:t>
            </a:r>
            <a:r>
              <a:rPr lang="en-US" altLang="zh-CN" sz="1200" b="0">
                <a:solidFill>
                  <a:srgbClr val="131413"/>
                </a:solidFill>
                <a:latin typeface="Times New Roman" panose="02020603050405020304" charset="0"/>
                <a:cs typeface="Times New Roman" panose="02020603050405020304" charset="0"/>
              </a:rPr>
              <a:t>H NMR spectra of serum of heroin self-administrated rats.  Keys: Tyr, tyrosine; PC, phosphocholine; GPC, glycerol phosphocholine; Val, valine; Leu, leucine; Ile, isoleucine; His, histidine; Phe, phenylalanine; </a:t>
            </a:r>
            <a:endParaRPr lang="en-US" altLang="zh-CN" sz="1200" b="0">
              <a:solidFill>
                <a:srgbClr val="131413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67" name="图片 67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3930" y="403860"/>
            <a:ext cx="7446010" cy="5324475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3556000" y="5925185"/>
            <a:ext cx="5080000" cy="460375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altLang="zh-CN" sz="1200" b="0">
                <a:latin typeface="Times New Roman" panose="02020603050405020304" charset="0"/>
                <a:cs typeface="Times New Roman" panose="02020603050405020304" charset="0"/>
              </a:rPr>
              <a:t>Fig. S2. The PCA model for comparison SA and control group generated by SIMICA-P software. n=8 for control group, n=7 for SA group. </a:t>
            </a:r>
            <a:endParaRPr lang="en-US" altLang="zh-CN" sz="1200" b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3" name="表格 2"/>
          <p:cNvGraphicFramePr/>
          <p:nvPr/>
        </p:nvGraphicFramePr>
        <p:xfrm>
          <a:off x="1524000" y="361950"/>
          <a:ext cx="8531225" cy="6477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06120"/>
                <a:gridCol w="1325245"/>
                <a:gridCol w="982345"/>
                <a:gridCol w="3811270"/>
                <a:gridCol w="1706245"/>
              </a:tblGrid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o.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Metabolites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KEGG ID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hemical shift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orrelation coefficients for      SA vs. Control</a:t>
                      </a:r>
                      <a:endParaRPr lang="en-US" altLang="zh-CN" sz="1200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holine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00114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.19(s),</a:t>
                      </a: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3.53(t), 4.07(t)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757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PC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00157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.21</a:t>
                      </a: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(s), 3.60(t), 4.17(t)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815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GPC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00670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3.21(s) ,3.69(t), 4.33(t)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815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4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Glucose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00267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3.26(dd), 3.41(dd), 3.50(t) ,3.54(dd), 3.71(dd), 3.78(m) ,3.84(m) ,5.23(d)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913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5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Fumarate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00122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6.52(s)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0.821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6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Pyruvate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00022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.36(s)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0.919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7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3-HB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01089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1.20(d) ,2.32(dd), 2.42(dd), 4.16(m)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0.780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8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Acetoacetate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00164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.27(s)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783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9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Glutamine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00064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.17(m), 2.46(m), 3.78(m)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775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0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Phe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00079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7.33(m) , 7.38(m) 7.43(m)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881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1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His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00135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7.06(s) ,7.80(s)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0.833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2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Acetate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C00033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.91(s)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712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3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Lactate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C01432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1.33(d), 4.12(q)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-0.974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4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NAG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= =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2.04(s)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764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5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OAG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= =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2.13(s)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0.793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  <a:tr h="3810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16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solidFill>
                            <a:srgbClr val="000000"/>
                          </a:solidFill>
                          <a:latin typeface="Times New Roman" panose="02020603050405020304" charset="0"/>
                          <a:cs typeface="Times New Roman" panose="02020603050405020304" charset="0"/>
                        </a:rPr>
                        <a:t>Lipid</a:t>
                      </a:r>
                      <a:endParaRPr lang="en-US" altLang="zh-CN" sz="1200" b="0">
                        <a:solidFill>
                          <a:srgbClr val="000000"/>
                        </a:solidFill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= =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t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0.86(t),0.88(t),1.27(m),2.01(m), 2.76(m), 5.30(m)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altLang="zh-CN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-0.796</a:t>
                      </a:r>
                      <a:endParaRPr lang="en-US" altLang="zh-CN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0" marR="0" marT="0" marB="1" vert="horz" anchor="ctr"/>
                </a:tc>
              </a:tr>
            </a:tbl>
          </a:graphicData>
        </a:graphic>
      </p:graphicFrame>
      <p:sp>
        <p:nvSpPr>
          <p:cNvPr id="100" name="文本框 99"/>
          <p:cNvSpPr txBox="1"/>
          <p:nvPr/>
        </p:nvSpPr>
        <p:spPr>
          <a:xfrm>
            <a:off x="1689735" y="19685"/>
            <a:ext cx="8812530" cy="27559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altLang="zh-CN" sz="1200" b="0">
                <a:solidFill>
                  <a:srgbClr val="000000"/>
                </a:solidFill>
                <a:latin typeface="Times New Roman" panose="02020603050405020304" charset="0"/>
                <a:cs typeface="Times New Roman" panose="02020603050405020304" charset="0"/>
              </a:rPr>
              <a:t>Table S</a:t>
            </a:r>
            <a:r>
              <a:rPr lang="en-US" altLang="zh-CN" sz="1200" b="0">
                <a:latin typeface="Times New Roman" panose="02020603050405020304" charset="0"/>
                <a:cs typeface="Times New Roman" panose="02020603050405020304" charset="0"/>
              </a:rPr>
              <a:t>1 Correlation coefficients for statistically significant metabolites found in the comparison between SA and control group</a:t>
            </a:r>
            <a:endParaRPr lang="en-US" altLang="zh-CN" sz="1200" b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37</Words>
  <Application>WPS 演示</Application>
  <PresentationFormat>宽屏</PresentationFormat>
  <Paragraphs>176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2" baseType="lpstr">
      <vt:lpstr>Arial</vt:lpstr>
      <vt:lpstr>宋体</vt:lpstr>
      <vt:lpstr>Wingdings</vt:lpstr>
      <vt:lpstr>Arial Unicode MS</vt:lpstr>
      <vt:lpstr>Calibri Light</vt:lpstr>
      <vt:lpstr>Calibri</vt:lpstr>
      <vt:lpstr>微软雅黑</vt:lpstr>
      <vt:lpstr>Times New Roman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</dc:creator>
  <cp:lastModifiedBy>宁婷婷</cp:lastModifiedBy>
  <cp:revision>6</cp:revision>
  <dcterms:created xsi:type="dcterms:W3CDTF">2015-05-05T08:02:00Z</dcterms:created>
  <dcterms:modified xsi:type="dcterms:W3CDTF">2017-12-26T02:57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929</vt:lpwstr>
  </property>
</Properties>
</file>